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065DDE82-79B1-012B-EF93-A9BA5C1F04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6AA934BB-E601-F63C-147A-2FC82D4CA7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E90DEBCC-9D9D-D8B7-F624-3DAAC9C41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029C764C-2DFB-B87D-864F-73FF5F46B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C9BE497C-C5F1-27A6-C9D7-16F52EA8D7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997098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5DDB7FCA-387D-B9A9-D687-97CB69B938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C755CA3E-FB56-A8DF-D510-B12FC2C0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D8DBD4C1-5B8C-97F5-4E81-237F384B5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44953252-D2A1-66B7-6FDF-BA85A2E47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DE0144B5-DDBB-26B6-C9DA-027CEC243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98809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39870057-D3D8-5A77-BE8C-D8BFA965F8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27134AA9-BF0B-79C4-6627-324F539112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6819BF24-11FF-9507-3475-B8FF26F8D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F11BCF8E-7DBC-45F1-5ED9-2AF1AC81B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70BA9513-779E-B6A9-685C-5B8C88929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296935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58792289-B7FB-46FD-73C6-7A0D3FDFA0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18C0710B-2E5D-148D-49D7-2AB7E2A05F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4AEC3D93-52E1-42BE-A7C2-8A482AF57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5403796F-EE18-4250-19D4-A0A455B54D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3A19DB68-94BA-D2D0-3C1F-47BA96A65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91564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6EAF63BB-F248-A165-C252-A41037F0AB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53100557-B3A8-32D7-FF34-C47082457F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4421F3A8-F993-1E82-E01D-6FD3841CD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D28CAC43-D04F-6A0E-EE60-DCB2C7F82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FB143D5F-43CF-9C69-E27C-0182E2E8F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93364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695816CB-D1A5-86A4-8608-55A148AD16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31EFA408-C76E-D5E4-A13A-3A0536AADE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C10D6A87-00FA-CC8F-38A3-BFECBA57AC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1B86CFE6-D9C6-1ED6-6BAC-812D8B087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F26C60B7-6DFA-A600-12D8-45DF0A20B8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A682595A-BEFC-8583-056E-4835991F5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55500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643599E6-BDE6-8DEF-B92C-39387EEA65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D7203171-5129-59B3-FABF-D577ACCD21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E41AC8F8-5A39-61FF-BED0-73124FE712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D2881C97-A22B-4395-6527-1CD574DEB7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C6FC94CE-FDC3-E02C-4B58-8298E51BB7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57760DF8-848E-7199-1ED8-521FF6B99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EF6065C6-450E-B6DB-9B8C-9AA5D3C89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F527FC88-8973-BB98-967E-5D6CA242E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657704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E9E4A086-3EE2-E0B5-F1E8-2920780B31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61ADE1B2-EEC1-3C4D-E6E5-5C02D53AD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D7E16F0E-9751-BCF3-F73B-55AE9DFC3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C734CBA2-C907-49F3-84FE-B010C95B3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85259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BDB6CA76-A028-AC57-BAC0-E8D99026E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C2575233-5423-2956-3749-D245552F3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E3E0819F-89FB-FA20-FBB4-4DBABE162F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95378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162869D1-76C6-E005-252E-F9B86DE87D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2A8BF466-9523-A027-2A22-681A6D25B9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191A0EE1-A702-B5F4-07C0-929DCFEC8E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0B0EE272-B9B3-80AB-8DAA-CAC0EBEE6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A7093B2D-2476-D078-1E14-C99E70242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A450EC48-3B62-6AF5-2455-CEF904544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302548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6EA12C44-B7DF-30EE-615E-95C0B3AC7A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A07007BB-B352-F69A-9EA4-60FEC58F01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F5280154-B1EC-7166-C2FC-7124AB2C34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6CAEC136-B27C-72C2-9643-D411729956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2371EE95-3206-8E4A-9833-01FFF2662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9FFDF447-D363-2C16-2084-E2B0F506C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354142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A35D4C5F-5043-391C-AE38-CC90A786E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D9A9248C-9844-5865-F43E-9F303120F8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999493B8-19AD-90A2-5EEE-7A000BB0F9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123103-6B83-4B1E-A3EC-C9BAA61E0C7B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7B57F19E-69F8-58BB-667E-95368A33B1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7F24DA69-8D47-CC0B-3D6B-15564B2BC8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E7F45-9BAF-4DE3-83B7-1FD8F957B6BC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2924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6" descr="รูปภาพประกอบด้วย แผนภาพ, ข้อความ, พล็อต, ไลน์&#10;&#10;เนื้อหาที่สร้างโดย AI อาจไม่ถูกต้อง">
            <a:extLst>
              <a:ext uri="{FF2B5EF4-FFF2-40B4-BE49-F238E27FC236}">
                <a16:creationId xmlns:a16="http://schemas.microsoft.com/office/drawing/2014/main" id="{71223B78-7F25-A76E-31BB-D0721541307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9604" y="1282472"/>
            <a:ext cx="5400183" cy="3289527"/>
          </a:xfrm>
          <a:prstGeom prst="rect">
            <a:avLst/>
          </a:prstGeom>
          <a:noFill/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CE10C152-EB64-CD1A-81C8-F5AE2A687AAF}"/>
              </a:ext>
            </a:extLst>
          </p:cNvPr>
          <p:cNvSpPr txBox="1"/>
          <p:nvPr/>
        </p:nvSpPr>
        <p:spPr>
          <a:xfrm>
            <a:off x="2572414" y="4934308"/>
            <a:ext cx="6094562" cy="4778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</a:t>
            </a:r>
            <a:r>
              <a:rPr lang="en-I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Figure S7: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The CSM extract scanned over the wavelength range between 200–900 nm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23883843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00253967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5</Words>
  <Application>Microsoft Office PowerPoint</Application>
  <PresentationFormat>แบบจอกว้าง</PresentationFormat>
  <Paragraphs>1</Paragraphs>
  <Slides>2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2</cp:revision>
  <dcterms:created xsi:type="dcterms:W3CDTF">2026-02-22T09:07:32Z</dcterms:created>
  <dcterms:modified xsi:type="dcterms:W3CDTF">2026-02-22T09:15:43Z</dcterms:modified>
</cp:coreProperties>
</file>